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640763" cy="4319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7F62FE-D1DE-4205-A719-6566F1086D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777744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31640" y="2497320"/>
            <a:ext cx="777744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4F006-6406-4541-AC63-9BACD3A0DC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416840" y="100800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31640" y="249732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416840" y="249732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D58EF-2EEE-4B3B-BAFD-1FA57F09752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250416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61440" y="1008000"/>
            <a:ext cx="250416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91240" y="1008000"/>
            <a:ext cx="250416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31640" y="2497320"/>
            <a:ext cx="250416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61440" y="2497320"/>
            <a:ext cx="250416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91240" y="2497320"/>
            <a:ext cx="250416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C2E4B-A027-4D5C-BAF4-1F8EDF1F34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31640" y="1008000"/>
            <a:ext cx="7777440" cy="285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EBE4C-4837-42A2-BD01-84B9D0407B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7777440" cy="28512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83970-1DDD-4D7C-82FD-F2F6ED8F01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3795120" cy="28512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416840" y="1008000"/>
            <a:ext cx="3795120" cy="28512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F5BD2-48AE-4E46-AA42-149BEA9A92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EA732-E4D5-4F8E-94D0-440352BCD6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31640" y="172800"/>
            <a:ext cx="7777440" cy="33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15AA69-6949-429E-855A-4A917AC21C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416840" y="1008000"/>
            <a:ext cx="3795120" cy="28512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31640" y="249732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B083D-4D38-4CC8-9722-6AD6073B39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3795120" cy="28512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416840" y="100800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416840" y="249732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8023D-009D-4C53-ADBB-1364CFD59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31640" y="100800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416840" y="1008000"/>
            <a:ext cx="379512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31640" y="2497320"/>
            <a:ext cx="7777440" cy="13597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3F426-9704-4BE2-A9F6-1C9B6F1A51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31640" y="172800"/>
            <a:ext cx="7777440" cy="71892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ctr">
            <a:noAutofit/>
          </a:bodyPr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31640" y="1008000"/>
            <a:ext cx="7777440" cy="285120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rmAutofit fontScale="78000"/>
          </a:bodyPr>
          <a:p>
            <a:pPr marL="235080" indent="-235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508680" indent="-1951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782280" indent="-15696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094400" indent="-1555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407600" indent="-15588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407600" indent="-15588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407600" indent="-15588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31280" y="3935160"/>
            <a:ext cx="2016360" cy="29988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Autofit/>
          </a:bodyPr>
          <a:lstStyle>
            <a:lvl1pPr indent="0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952720" y="3935160"/>
            <a:ext cx="2735280" cy="29988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Autofit/>
          </a:bodyPr>
          <a:lstStyle>
            <a:lvl1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192360" y="3935160"/>
            <a:ext cx="2016360" cy="299880"/>
          </a:xfrm>
          <a:prstGeom prst="rect">
            <a:avLst/>
          </a:prstGeom>
          <a:noFill/>
          <a:ln w="0">
            <a:noFill/>
          </a:ln>
        </p:spPr>
        <p:txBody>
          <a:bodyPr lIns="80280" rIns="80280" tIns="39960" bIns="39960" anchor="t">
            <a:noAutofit/>
          </a:bodyPr>
          <a:lstStyle>
            <a:lvl1pPr indent="0" algn="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01720"/>
                <a:tab algn="l" pos="1603440"/>
                <a:tab algn="l" pos="2405160"/>
                <a:tab algn="l" pos="3206880"/>
                <a:tab algn="l" pos="4008600"/>
                <a:tab algn="l" pos="4809960"/>
                <a:tab algn="l" pos="5611680"/>
                <a:tab algn="l" pos="6413400"/>
                <a:tab algn="l" pos="7215120"/>
                <a:tab algn="l" pos="8016840"/>
                <a:tab algn="l" pos="8818560"/>
                <a:tab algn="l" pos="9620280"/>
                <a:tab algn="l" pos="10422000"/>
              </a:tabLst>
            </a:pPr>
            <a:fld id="{370D1D75-537E-4B7D-ABE6-9E78FE884F6A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39760" y="2421000"/>
            <a:ext cx="5349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51000" y="1193760"/>
            <a:ext cx="77724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rot="10800000">
            <a:off x="566280" y="1025280"/>
            <a:ext cx="228600" cy="345960"/>
          </a:xfrm>
          <a:custGeom>
            <a:avLst/>
            <a:gdLst>
              <a:gd name="textAreaLeft" fmla="*/ 0 w 228600"/>
              <a:gd name="textAreaRight" fmla="*/ 228960 w 2286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028880" y="1022400"/>
            <a:ext cx="66600" cy="345960"/>
          </a:xfrm>
          <a:custGeom>
            <a:avLst/>
            <a:gdLst>
              <a:gd name="textAreaLeft" fmla="*/ 0 w 66600"/>
              <a:gd name="textAreaRight" fmla="*/ 66960 w 666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0800000">
            <a:off x="2065320" y="1025280"/>
            <a:ext cx="200160" cy="345960"/>
          </a:xfrm>
          <a:custGeom>
            <a:avLst/>
            <a:gdLst>
              <a:gd name="textAreaLeft" fmla="*/ 0 w 200160"/>
              <a:gd name="textAreaRight" fmla="*/ 200520 w 20016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0800000">
            <a:off x="4030560" y="1025280"/>
            <a:ext cx="238320" cy="345960"/>
          </a:xfrm>
          <a:custGeom>
            <a:avLst/>
            <a:gdLst>
              <a:gd name="textAreaLeft" fmla="*/ 0 w 238320"/>
              <a:gd name="textAreaRight" fmla="*/ 238680 w 23832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0800000">
            <a:off x="6921360" y="1025280"/>
            <a:ext cx="152640" cy="345960"/>
          </a:xfrm>
          <a:custGeom>
            <a:avLst/>
            <a:gdLst>
              <a:gd name="textAreaLeft" fmla="*/ 0 w 152640"/>
              <a:gd name="textAreaRight" fmla="*/ 153000 w 15264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461360" y="1022400"/>
            <a:ext cx="377640" cy="345960"/>
          </a:xfrm>
          <a:custGeom>
            <a:avLst/>
            <a:gdLst>
              <a:gd name="textAreaLeft" fmla="*/ 0 w 377640"/>
              <a:gd name="textAreaRight" fmla="*/ 378000 w 37764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7280000">
            <a:off x="3888000" y="-162360"/>
            <a:ext cx="17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7280000">
            <a:off x="5116680" y="-165240"/>
            <a:ext cx="178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7280000">
            <a:off x="-91440" y="-163800"/>
            <a:ext cx="17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7280000">
            <a:off x="1010160" y="-164160"/>
            <a:ext cx="17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rot="17280000">
            <a:off x="2176920" y="-163800"/>
            <a:ext cx="17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7280000">
            <a:off x="4411080" y="-163440"/>
            <a:ext cx="1776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7280000">
            <a:off x="6212160" y="-163800"/>
            <a:ext cx="17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1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7280000">
            <a:off x="6921000" y="-167760"/>
            <a:ext cx="177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-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1280" y="-27000"/>
            <a:ext cx="3194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i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sa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uH9 (85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019160" y="2422440"/>
            <a:ext cx="51339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451560" y="2408400"/>
            <a:ext cx="219240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515280" y="2233440"/>
            <a:ext cx="282240" cy="346320"/>
          </a:xfrm>
          <a:custGeom>
            <a:avLst/>
            <a:gdLst>
              <a:gd name="textAreaLeft" fmla="*/ 0 w 282240"/>
              <a:gd name="textAreaRight" fmla="*/ 282600 w 282240"/>
              <a:gd name="textAreaTop" fmla="*/ 0 h 346320"/>
              <a:gd name="textAreaBottom" fmla="*/ 346680 h 346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977160" y="2233440"/>
            <a:ext cx="63360" cy="346320"/>
          </a:xfrm>
          <a:custGeom>
            <a:avLst/>
            <a:gdLst>
              <a:gd name="textAreaLeft" fmla="*/ 0 w 63360"/>
              <a:gd name="textAreaRight" fmla="*/ 63720 w 63360"/>
              <a:gd name="textAreaTop" fmla="*/ 0 h 346320"/>
              <a:gd name="textAreaBottom" fmla="*/ 346680 h 346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0800000">
            <a:off x="7683480" y="2234880"/>
            <a:ext cx="106560" cy="345960"/>
          </a:xfrm>
          <a:custGeom>
            <a:avLst/>
            <a:gdLst>
              <a:gd name="textAreaLeft" fmla="*/ 0 w 106560"/>
              <a:gd name="textAreaRight" fmla="*/ 106920 w 10656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0800000">
            <a:off x="7850160" y="2234880"/>
            <a:ext cx="179280" cy="345960"/>
          </a:xfrm>
          <a:custGeom>
            <a:avLst/>
            <a:gdLst>
              <a:gd name="textAreaLeft" fmla="*/ 0 w 179280"/>
              <a:gd name="textAreaRight" fmla="*/ 179640 w 1792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rot="10800000">
            <a:off x="8091000" y="2234880"/>
            <a:ext cx="63720" cy="345960"/>
          </a:xfrm>
          <a:custGeom>
            <a:avLst/>
            <a:gdLst>
              <a:gd name="textAreaLeft" fmla="*/ 0 w 63720"/>
              <a:gd name="textAreaRight" fmla="*/ 64080 w 6372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8292960" y="2233440"/>
            <a:ext cx="282600" cy="346320"/>
          </a:xfrm>
          <a:custGeom>
            <a:avLst/>
            <a:gdLst>
              <a:gd name="textAreaLeft" fmla="*/ 0 w 282600"/>
              <a:gd name="textAreaRight" fmla="*/ 282960 w 282600"/>
              <a:gd name="textAreaTop" fmla="*/ 0 h 346320"/>
              <a:gd name="textAreaBottom" fmla="*/ 346680 h 346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7280000">
            <a:off x="6400800" y="2570040"/>
            <a:ext cx="177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87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7280000">
            <a:off x="5688000" y="2560680"/>
            <a:ext cx="177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85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7280000">
            <a:off x="6033960" y="2560680"/>
            <a:ext cx="177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86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17280000">
            <a:off x="7474320" y="2558160"/>
            <a:ext cx="178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91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718080" y="2252520"/>
            <a:ext cx="280800" cy="344520"/>
          </a:xfrm>
          <a:custGeom>
            <a:avLst/>
            <a:gdLst>
              <a:gd name="textAreaLeft" fmla="*/ 0 w 280800"/>
              <a:gd name="textAreaRight" fmla="*/ 281160 w 28080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195800" y="2252520"/>
            <a:ext cx="419040" cy="344520"/>
          </a:xfrm>
          <a:custGeom>
            <a:avLst/>
            <a:gdLst>
              <a:gd name="textAreaLeft" fmla="*/ 0 w 419040"/>
              <a:gd name="textAreaRight" fmla="*/ 419400 w 41904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032360" y="2252520"/>
            <a:ext cx="34920" cy="344520"/>
          </a:xfrm>
          <a:custGeom>
            <a:avLst/>
            <a:gdLst>
              <a:gd name="textAreaLeft" fmla="*/ 0 w 34920"/>
              <a:gd name="textAreaRight" fmla="*/ 35280 w 3492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971960" y="2252520"/>
            <a:ext cx="96840" cy="344520"/>
          </a:xfrm>
          <a:custGeom>
            <a:avLst/>
            <a:gdLst>
              <a:gd name="textAreaLeft" fmla="*/ 0 w 96840"/>
              <a:gd name="textAreaRight" fmla="*/ 97200 w 9684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084640" y="2252520"/>
            <a:ext cx="352440" cy="344520"/>
          </a:xfrm>
          <a:custGeom>
            <a:avLst/>
            <a:gdLst>
              <a:gd name="textAreaLeft" fmla="*/ 0 w 352440"/>
              <a:gd name="textAreaRight" fmla="*/ 352800 w 35244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702400" y="2252520"/>
            <a:ext cx="187200" cy="344520"/>
          </a:xfrm>
          <a:custGeom>
            <a:avLst/>
            <a:gdLst>
              <a:gd name="textAreaLeft" fmla="*/ 0 w 187200"/>
              <a:gd name="textAreaRight" fmla="*/ 187560 w 18720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6078600" y="2252520"/>
            <a:ext cx="31680" cy="344520"/>
          </a:xfrm>
          <a:custGeom>
            <a:avLst/>
            <a:gdLst>
              <a:gd name="textAreaLeft" fmla="*/ 0 w 31680"/>
              <a:gd name="textAreaRight" fmla="*/ 32040 w 3168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0800000">
            <a:off x="5477040" y="2253960"/>
            <a:ext cx="187200" cy="345960"/>
          </a:xfrm>
          <a:custGeom>
            <a:avLst/>
            <a:gdLst>
              <a:gd name="textAreaLeft" fmla="*/ 0 w 187200"/>
              <a:gd name="textAreaRight" fmla="*/ 187560 w 1872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17280000">
            <a:off x="2836800" y="2538360"/>
            <a:ext cx="177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47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17280000">
            <a:off x="5116320" y="2560680"/>
            <a:ext cx="177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54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833480" y="2252520"/>
            <a:ext cx="163440" cy="344520"/>
          </a:xfrm>
          <a:custGeom>
            <a:avLst/>
            <a:gdLst>
              <a:gd name="textAreaLeft" fmla="*/ 0 w 163440"/>
              <a:gd name="textAreaRight" fmla="*/ 163800 w 16344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0800000">
            <a:off x="3084120" y="2253960"/>
            <a:ext cx="243000" cy="345960"/>
          </a:xfrm>
          <a:custGeom>
            <a:avLst/>
            <a:gdLst>
              <a:gd name="textAreaLeft" fmla="*/ 0 w 243000"/>
              <a:gd name="textAreaRight" fmla="*/ 243360 w 2430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0800000">
            <a:off x="2225160" y="2253960"/>
            <a:ext cx="166680" cy="345960"/>
          </a:xfrm>
          <a:custGeom>
            <a:avLst/>
            <a:gdLst>
              <a:gd name="textAreaLeft" fmla="*/ 0 w 166680"/>
              <a:gd name="textAreaRight" fmla="*/ 166680 w 1666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0800000">
            <a:off x="1631880" y="2253960"/>
            <a:ext cx="168480" cy="345960"/>
          </a:xfrm>
          <a:custGeom>
            <a:avLst/>
            <a:gdLst>
              <a:gd name="textAreaLeft" fmla="*/ 0 w 168480"/>
              <a:gd name="textAreaRight" fmla="*/ 168840 w 1684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10800000">
            <a:off x="1076040" y="2253960"/>
            <a:ext cx="150840" cy="345960"/>
          </a:xfrm>
          <a:custGeom>
            <a:avLst/>
            <a:gdLst>
              <a:gd name="textAreaLeft" fmla="*/ 0 w 150840"/>
              <a:gd name="textAreaRight" fmla="*/ 151200 w 15084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rot="10800000">
            <a:off x="1523520" y="2253960"/>
            <a:ext cx="55800" cy="345960"/>
          </a:xfrm>
          <a:custGeom>
            <a:avLst/>
            <a:gdLst>
              <a:gd name="textAreaLeft" fmla="*/ 0 w 55800"/>
              <a:gd name="textAreaRight" fmla="*/ 56160 w 558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014560" y="2252520"/>
            <a:ext cx="31680" cy="344520"/>
          </a:xfrm>
          <a:custGeom>
            <a:avLst/>
            <a:gdLst>
              <a:gd name="textAreaLeft" fmla="*/ 0 w 31680"/>
              <a:gd name="textAreaRight" fmla="*/ 32040 w 3168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597040" y="2252520"/>
            <a:ext cx="52560" cy="344520"/>
          </a:xfrm>
          <a:custGeom>
            <a:avLst/>
            <a:gdLst>
              <a:gd name="textAreaLeft" fmla="*/ 0 w 52560"/>
              <a:gd name="textAreaRight" fmla="*/ 52920 w 5256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10800000">
            <a:off x="2757240" y="2253960"/>
            <a:ext cx="276120" cy="345960"/>
          </a:xfrm>
          <a:custGeom>
            <a:avLst/>
            <a:gdLst>
              <a:gd name="textAreaLeft" fmla="*/ 0 w 276120"/>
              <a:gd name="textAreaRight" fmla="*/ 276480 w 27612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rot="10800000">
            <a:off x="2722680" y="2253960"/>
            <a:ext cx="33120" cy="345960"/>
          </a:xfrm>
          <a:custGeom>
            <a:avLst/>
            <a:gdLst>
              <a:gd name="textAreaLeft" fmla="*/ 0 w 33120"/>
              <a:gd name="textAreaRight" fmla="*/ 33480 w 3312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rot="10800000">
            <a:off x="2064960" y="2253960"/>
            <a:ext cx="73080" cy="345960"/>
          </a:xfrm>
          <a:custGeom>
            <a:avLst/>
            <a:gdLst>
              <a:gd name="textAreaLeft" fmla="*/ 0 w 73080"/>
              <a:gd name="textAreaRight" fmla="*/ 73440 w 730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413000" y="2252520"/>
            <a:ext cx="99720" cy="344520"/>
          </a:xfrm>
          <a:custGeom>
            <a:avLst/>
            <a:gdLst>
              <a:gd name="textAreaLeft" fmla="*/ 0 w 99720"/>
              <a:gd name="textAreaRight" fmla="*/ 100080 w 99720"/>
              <a:gd name="textAreaTop" fmla="*/ 0 h 344520"/>
              <a:gd name="textAreaBottom" fmla="*/ 344880 h 3445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7280000">
            <a:off x="167400" y="2548440"/>
            <a:ext cx="177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134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0800000">
            <a:off x="415800" y="2253960"/>
            <a:ext cx="277920" cy="345960"/>
          </a:xfrm>
          <a:custGeom>
            <a:avLst/>
            <a:gdLst>
              <a:gd name="textAreaLeft" fmla="*/ 0 w 277920"/>
              <a:gd name="textAreaRight" fmla="*/ 277920 w 27792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7280000">
            <a:off x="-448920" y="2549160"/>
            <a:ext cx="177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s04g4099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85640" y="1371600"/>
            <a:ext cx="303480" cy="880920"/>
          </a:xfrm>
          <a:custGeom>
            <a:avLst/>
            <a:gdLst/>
            <a:ahLst/>
            <a:rect l="l" t="t" r="r" b="b"/>
            <a:pathLst>
              <a:path w="222" h="387">
                <a:moveTo>
                  <a:pt x="108" y="0"/>
                </a:moveTo>
                <a:lnTo>
                  <a:pt x="222" y="0"/>
                </a:lnTo>
                <a:lnTo>
                  <a:pt x="153" y="387"/>
                </a:lnTo>
                <a:lnTo>
                  <a:pt x="0" y="384"/>
                </a:lnTo>
                <a:lnTo>
                  <a:pt x="108" y="0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808600" y="1373040"/>
            <a:ext cx="1212840" cy="866880"/>
          </a:xfrm>
          <a:custGeom>
            <a:avLst/>
            <a:gdLst/>
            <a:ahLst/>
            <a:rect l="l" t="t" r="r" b="b"/>
            <a:pathLst>
              <a:path w="768" h="384">
                <a:moveTo>
                  <a:pt x="0" y="0"/>
                </a:moveTo>
                <a:lnTo>
                  <a:pt x="32" y="0"/>
                </a:lnTo>
                <a:lnTo>
                  <a:pt x="768" y="380"/>
                </a:lnTo>
                <a:lnTo>
                  <a:pt x="732" y="384"/>
                </a:lnTo>
                <a:lnTo>
                  <a:pt x="0" y="0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7462800" y="1357200"/>
            <a:ext cx="1044720" cy="874800"/>
          </a:xfrm>
          <a:custGeom>
            <a:avLst/>
            <a:gdLst/>
            <a:ahLst/>
            <a:rect l="l" t="t" r="r" b="b"/>
            <a:pathLst>
              <a:path w="672" h="384">
                <a:moveTo>
                  <a:pt x="0" y="0"/>
                </a:moveTo>
                <a:lnTo>
                  <a:pt x="184" y="0"/>
                </a:lnTo>
                <a:lnTo>
                  <a:pt x="672" y="384"/>
                </a:lnTo>
                <a:lnTo>
                  <a:pt x="532" y="384"/>
                </a:lnTo>
                <a:lnTo>
                  <a:pt x="0" y="0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71280" y="4032360"/>
            <a:ext cx="210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ice Chr4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515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741240" y="2274840"/>
            <a:ext cx="62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/ /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186600" y="227664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/ /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0800000">
            <a:off x="7216920" y="2233440"/>
            <a:ext cx="155520" cy="346320"/>
          </a:xfrm>
          <a:custGeom>
            <a:avLst/>
            <a:gdLst>
              <a:gd name="textAreaLeft" fmla="*/ 0 w 155520"/>
              <a:gd name="textAreaRight" fmla="*/ 155520 w 155520"/>
              <a:gd name="textAreaTop" fmla="*/ 0 h 346320"/>
              <a:gd name="textAreaBottom" fmla="*/ 346680 h 3463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6961320" y="1384200"/>
            <a:ext cx="411120" cy="833400"/>
          </a:xfrm>
          <a:custGeom>
            <a:avLst/>
            <a:gdLst/>
            <a:ahLst/>
            <a:rect l="l" t="t" r="r" b="b"/>
            <a:pathLst>
              <a:path w="264" h="366">
                <a:moveTo>
                  <a:pt x="0" y="0"/>
                </a:moveTo>
                <a:lnTo>
                  <a:pt x="66" y="0"/>
                </a:lnTo>
                <a:lnTo>
                  <a:pt x="264" y="366"/>
                </a:lnTo>
                <a:lnTo>
                  <a:pt x="192" y="366"/>
                </a:lnTo>
                <a:lnTo>
                  <a:pt x="0" y="0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878040" y="3683160"/>
            <a:ext cx="513216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477120" y="3683160"/>
            <a:ext cx="189540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976480" y="3753000"/>
            <a:ext cx="90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4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962680" y="3753000"/>
            <a:ext cx="109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7199280" y="375300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4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39680" y="3683160"/>
            <a:ext cx="4334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01520" y="3753000"/>
            <a:ext cx="7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.5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50800" y="3753000"/>
            <a:ext cx="90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 K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rot="10800000">
            <a:off x="1515960" y="1025280"/>
            <a:ext cx="370080" cy="345960"/>
          </a:xfrm>
          <a:custGeom>
            <a:avLst/>
            <a:gdLst>
              <a:gd name="textAreaLeft" fmla="*/ 0 w 370080"/>
              <a:gd name="textAreaRight" fmla="*/ 370440 w 3700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619360" y="1025640"/>
            <a:ext cx="901800" cy="345960"/>
          </a:xfrm>
          <a:custGeom>
            <a:avLst/>
            <a:gdLst>
              <a:gd name="textAreaLeft" fmla="*/ 0 w 901800"/>
              <a:gd name="textAreaRight" fmla="*/ 902160 w 9018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570560" y="1025640"/>
            <a:ext cx="144360" cy="345960"/>
          </a:xfrm>
          <a:custGeom>
            <a:avLst/>
            <a:gdLst>
              <a:gd name="textAreaLeft" fmla="*/ 0 w 144360"/>
              <a:gd name="textAreaRight" fmla="*/ 144360 w 14436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792680" y="1025640"/>
            <a:ext cx="879480" cy="345960"/>
          </a:xfrm>
          <a:custGeom>
            <a:avLst/>
            <a:gdLst>
              <a:gd name="textAreaLeft" fmla="*/ 0 w 879480"/>
              <a:gd name="textAreaRight" fmla="*/ 879840 w 8794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802480" y="1025640"/>
            <a:ext cx="52200" cy="345960"/>
          </a:xfrm>
          <a:custGeom>
            <a:avLst/>
            <a:gdLst>
              <a:gd name="textAreaLeft" fmla="*/ 0 w 52200"/>
              <a:gd name="textAreaRight" fmla="*/ 52560 w 5220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 rot="10800000">
            <a:off x="6110280" y="1025280"/>
            <a:ext cx="139680" cy="345960"/>
          </a:xfrm>
          <a:custGeom>
            <a:avLst/>
            <a:gdLst>
              <a:gd name="textAreaLeft" fmla="*/ 0 w 139680"/>
              <a:gd name="textAreaRight" fmla="*/ 140040 w 139680"/>
              <a:gd name="textAreaTop" fmla="*/ 0 h 345960"/>
              <a:gd name="textAreaBottom" fmla="*/ 346320 h 345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6200" y="0"/>
                </a:lnTo>
                <a:lnTo>
                  <a:pt x="21600" y="10800"/>
                </a:lnTo>
                <a:lnTo>
                  <a:pt x="16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ddddd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109520" y="1363680"/>
            <a:ext cx="771840" cy="888840"/>
          </a:xfrm>
          <a:custGeom>
            <a:avLst/>
            <a:gdLst/>
            <a:ahLst/>
            <a:rect l="l" t="t" r="r" b="b"/>
            <a:pathLst>
              <a:path w="363" h="390">
                <a:moveTo>
                  <a:pt x="234" y="3"/>
                </a:moveTo>
                <a:lnTo>
                  <a:pt x="363" y="0"/>
                </a:lnTo>
                <a:lnTo>
                  <a:pt x="51" y="390"/>
                </a:lnTo>
                <a:lnTo>
                  <a:pt x="0" y="390"/>
                </a:lnTo>
                <a:lnTo>
                  <a:pt x="234" y="3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619360" y="1363680"/>
            <a:ext cx="1300320" cy="880920"/>
          </a:xfrm>
          <a:custGeom>
            <a:avLst/>
            <a:gdLst/>
            <a:ahLst/>
            <a:rect l="l" t="t" r="r" b="b"/>
            <a:pathLst>
              <a:path w="612" h="387">
                <a:moveTo>
                  <a:pt x="0" y="0"/>
                </a:moveTo>
                <a:lnTo>
                  <a:pt x="318" y="0"/>
                </a:lnTo>
                <a:lnTo>
                  <a:pt x="612" y="387"/>
                </a:lnTo>
                <a:lnTo>
                  <a:pt x="513" y="387"/>
                </a:lnTo>
                <a:lnTo>
                  <a:pt x="0" y="0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811760" y="1371600"/>
            <a:ext cx="1905120" cy="866880"/>
          </a:xfrm>
          <a:custGeom>
            <a:avLst/>
            <a:gdLst/>
            <a:ahLst/>
            <a:rect l="l" t="t" r="r" b="b"/>
            <a:pathLst>
              <a:path w="903" h="387">
                <a:moveTo>
                  <a:pt x="0" y="6"/>
                </a:moveTo>
                <a:lnTo>
                  <a:pt x="300" y="0"/>
                </a:lnTo>
                <a:lnTo>
                  <a:pt x="903" y="387"/>
                </a:lnTo>
                <a:lnTo>
                  <a:pt x="804" y="381"/>
                </a:lnTo>
                <a:lnTo>
                  <a:pt x="0" y="6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570560" y="1363680"/>
            <a:ext cx="1541160" cy="888840"/>
          </a:xfrm>
          <a:custGeom>
            <a:avLst/>
            <a:gdLst/>
            <a:ahLst/>
            <a:rect l="l" t="t" r="r" b="b"/>
            <a:pathLst>
              <a:path w="726" h="390">
                <a:moveTo>
                  <a:pt x="0" y="3"/>
                </a:moveTo>
                <a:lnTo>
                  <a:pt x="51" y="0"/>
                </a:lnTo>
                <a:lnTo>
                  <a:pt x="726" y="390"/>
                </a:lnTo>
                <a:lnTo>
                  <a:pt x="708" y="390"/>
                </a:lnTo>
                <a:lnTo>
                  <a:pt x="0" y="3"/>
                </a:lnTo>
                <a:close/>
              </a:path>
            </a:pathLst>
          </a:custGeom>
          <a:solidFill>
            <a:srgbClr val="dddddd">
              <a:alpha val="50000"/>
            </a:srgbClr>
          </a:solidFill>
          <a:ln cap="rnd" w="9360">
            <a:solidFill>
              <a:srgbClr val="000000"/>
            </a:solidFill>
            <a:custDash>
              <a:ds d="100000" sp="1000"/>
            </a:custDash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18T21:55:39Z</dcterms:created>
  <dc:creator>CNRS</dc:creator>
  <dc:description/>
  <dc:language>en-US</dc:language>
  <cp:lastModifiedBy>CNRS</cp:lastModifiedBy>
  <dcterms:modified xsi:type="dcterms:W3CDTF">2008-01-18T21:59:58Z</dcterms:modified>
  <cp:revision>1</cp:revision>
  <dc:subject/>
  <dc:title>Diapositive 1</dc:title>
</cp:coreProperties>
</file>